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530CA-2B63-4CB6-BC20-FFEF2D2CC6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A3A9A-9529-41CD-AA37-A3CA0740DA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1E6A8-7461-44C2-AB4C-6A23172772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75DE8-FC28-46E8-A4DC-866D36A7FB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949AF-2A62-4AEA-B3EA-06D7D39394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3EE6A8-3C7A-429A-8F40-6F36D206B6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00EF2-3F25-4D30-B13C-33F9804F8E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85870-253B-4511-AE1C-0A4B29F1A1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93E8F8-94D9-4C18-9FF4-D7F903AC60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B2968-3213-409C-A7B6-BE95789D6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E694A-90A0-4714-B317-597FAB20F2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74055-C7BA-4CE4-9C5B-76AAED67AE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C4D9350-BF39-4344-BDED-52D46D780C24}" type="slidenum"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6"/>
          <p:cNvSpPr/>
          <p:nvPr/>
        </p:nvSpPr>
        <p:spPr>
          <a:xfrm>
            <a:off x="301680" y="9067680"/>
            <a:ext cx="59086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ure 1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Phylogenetic relationships, gene structure, and architecture of conserved protein motifs in AP2/ERF genes from C. sinense . The CsAP2/ERF family was allocated to five subfamilies (A. ERF subfamily with groups B1-B6, B. AP2 subfamily, C. RAV subfamily and Soloist, D. DREB subfamily with groups A1-A6) and Exon and UTR are represented by the box colored with green and yellow, respectively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形 2" descr=""/>
          <p:cNvPicPr/>
          <p:nvPr/>
        </p:nvPicPr>
        <p:blipFill>
          <a:blip r:embed="rId1"/>
          <a:stretch/>
        </p:blipFill>
        <p:spPr>
          <a:xfrm>
            <a:off x="471600" y="326880"/>
            <a:ext cx="5914800" cy="8649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6"/>
          <p:cNvSpPr/>
          <p:nvPr/>
        </p:nvSpPr>
        <p:spPr>
          <a:xfrm>
            <a:off x="590400" y="3568680"/>
            <a:ext cx="5300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ure 2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Expression levels of Ap2/ERFs the three leaf colors of C. sinen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图形 2" descr=""/>
          <p:cNvPicPr/>
          <p:nvPr/>
        </p:nvPicPr>
        <p:blipFill>
          <a:blip r:embed="rId1"/>
          <a:stretch/>
        </p:blipFill>
        <p:spPr>
          <a:xfrm>
            <a:off x="1644480" y="679320"/>
            <a:ext cx="2867040" cy="2543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6"/>
          <p:cNvSpPr/>
          <p:nvPr/>
        </p:nvSpPr>
        <p:spPr>
          <a:xfrm>
            <a:off x="380880" y="7975440"/>
            <a:ext cx="626112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ure 3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Quantitative real-time PCR (qRT-PCR) analysis of the expression patterns of fiv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genes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5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5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5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6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, and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8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) across various tissues, floral organs, and leaf and flower color variants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ymbidium sinens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. Statistical significance was evaluated using one-way analysis of variance (ANOVA), followed by Tukey’s honestly significant difference (HSD) post hoc test. Different lowercase letters above the bars indicate statistically significant differences among groups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&lt; 0.05)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图片 11" descr=""/>
          <p:cNvPicPr/>
          <p:nvPr/>
        </p:nvPicPr>
        <p:blipFill>
          <a:blip r:embed="rId1"/>
          <a:stretch/>
        </p:blipFill>
        <p:spPr>
          <a:xfrm>
            <a:off x="566640" y="479520"/>
            <a:ext cx="5702400" cy="7122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形 4" descr=""/>
          <p:cNvPicPr/>
          <p:nvPr/>
        </p:nvPicPr>
        <p:blipFill>
          <a:blip r:embed="rId1"/>
          <a:stretch/>
        </p:blipFill>
        <p:spPr>
          <a:xfrm>
            <a:off x="441360" y="90360"/>
            <a:ext cx="2487600" cy="9642600"/>
          </a:xfrm>
          <a:prstGeom prst="rect">
            <a:avLst/>
          </a:prstGeom>
          <a:ln w="0">
            <a:noFill/>
          </a:ln>
        </p:spPr>
      </p:pic>
      <p:sp>
        <p:nvSpPr>
          <p:cNvPr id="48" name="文本框 6"/>
          <p:cNvSpPr/>
          <p:nvPr/>
        </p:nvSpPr>
        <p:spPr>
          <a:xfrm>
            <a:off x="2708280" y="8142120"/>
            <a:ext cx="343224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ure 4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Expression levels of CsAP2/ERFs in flower and leaf of C. sinense before and after ABA treatment. LCK0, Initial leaf control samples; LCK1, Control sample of leaves after one month; LABA, Leaf samples after one month of ABA treatment. FCK0, Initial flower control samples; FCK1, Control sample of leaves after one month; FABA, flower samples after one month of ABA treatment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6"/>
          <p:cNvSpPr/>
          <p:nvPr/>
        </p:nvSpPr>
        <p:spPr>
          <a:xfrm>
            <a:off x="220680" y="5105520"/>
            <a:ext cx="64850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ure 5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Yeast one-hybrid assay confirming the direct binding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5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to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G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promoter.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G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promoter fragment was cloned into the pLacZi vector and co-transformed into the Saccharomyces cerevisiae stra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EGY48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along with either the pB42AD-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5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construct or the empty pB42AD vector as a negative control. Transformed yeast cells were grown for three days on SD/-Trp/-Ura medium supplemented with galactose, raffinose, and X-Gal to evaluate promoter activation. Blue coloration indicates a positive interaction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矩形 3"/>
          <p:cNvSpPr/>
          <p:nvPr/>
        </p:nvSpPr>
        <p:spPr>
          <a:xfrm>
            <a:off x="4254480" y="644400"/>
            <a:ext cx="182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等线"/>
              </a:rPr>
              <a:t>SD/-Trp/-Ura/Gal/Raf/X-Gal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矩形 4"/>
          <p:cNvSpPr/>
          <p:nvPr/>
        </p:nvSpPr>
        <p:spPr>
          <a:xfrm>
            <a:off x="2893320" y="644400"/>
            <a:ext cx="945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等线"/>
              </a:rPr>
              <a:t>SD/-Trp/-Ur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直接连接符 5"/>
          <p:cNvSpPr/>
          <p:nvPr/>
        </p:nvSpPr>
        <p:spPr>
          <a:xfrm>
            <a:off x="2523960" y="914400"/>
            <a:ext cx="1702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直接连接符 7"/>
          <p:cNvSpPr/>
          <p:nvPr/>
        </p:nvSpPr>
        <p:spPr>
          <a:xfrm>
            <a:off x="4280040" y="912960"/>
            <a:ext cx="1701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矩形 8"/>
          <p:cNvSpPr/>
          <p:nvPr/>
        </p:nvSpPr>
        <p:spPr>
          <a:xfrm>
            <a:off x="2576880" y="9111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矩形 9"/>
          <p:cNvSpPr/>
          <p:nvPr/>
        </p:nvSpPr>
        <p:spPr>
          <a:xfrm>
            <a:off x="2959920" y="911160"/>
            <a:ext cx="40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0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矩形 10"/>
          <p:cNvSpPr/>
          <p:nvPr/>
        </p:nvSpPr>
        <p:spPr>
          <a:xfrm>
            <a:off x="3345120" y="911160"/>
            <a:ext cx="49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0.0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矩形 11"/>
          <p:cNvSpPr/>
          <p:nvPr/>
        </p:nvSpPr>
        <p:spPr>
          <a:xfrm>
            <a:off x="3788640" y="911160"/>
            <a:ext cx="49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0.0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12"/>
          <p:cNvSpPr/>
          <p:nvPr/>
        </p:nvSpPr>
        <p:spPr>
          <a:xfrm>
            <a:off x="1781280" y="2435400"/>
            <a:ext cx="72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Posi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13"/>
          <p:cNvSpPr/>
          <p:nvPr/>
        </p:nvSpPr>
        <p:spPr>
          <a:xfrm>
            <a:off x="1731960" y="1498680"/>
            <a:ext cx="76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Nege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14"/>
          <p:cNvSpPr/>
          <p:nvPr/>
        </p:nvSpPr>
        <p:spPr>
          <a:xfrm>
            <a:off x="1046160" y="3214800"/>
            <a:ext cx="145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pB42AD+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sA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-pr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15"/>
          <p:cNvSpPr/>
          <p:nvPr/>
        </p:nvSpPr>
        <p:spPr>
          <a:xfrm>
            <a:off x="371520" y="4102200"/>
            <a:ext cx="21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pB42AD-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sAP2_5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+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sA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-pr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矩形 25"/>
          <p:cNvSpPr/>
          <p:nvPr/>
        </p:nvSpPr>
        <p:spPr>
          <a:xfrm>
            <a:off x="4345200" y="9064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矩形 26"/>
          <p:cNvSpPr/>
          <p:nvPr/>
        </p:nvSpPr>
        <p:spPr>
          <a:xfrm>
            <a:off x="4728240" y="906480"/>
            <a:ext cx="40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0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矩形 27"/>
          <p:cNvSpPr/>
          <p:nvPr/>
        </p:nvSpPr>
        <p:spPr>
          <a:xfrm>
            <a:off x="5113440" y="906480"/>
            <a:ext cx="49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0.0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矩形 28"/>
          <p:cNvSpPr/>
          <p:nvPr/>
        </p:nvSpPr>
        <p:spPr>
          <a:xfrm>
            <a:off x="5557320" y="906480"/>
            <a:ext cx="49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等线"/>
              </a:rPr>
              <a:t>0.0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图片 1" descr=""/>
          <p:cNvPicPr/>
          <p:nvPr/>
        </p:nvPicPr>
        <p:blipFill>
          <a:blip r:embed="rId1"/>
          <a:stretch/>
        </p:blipFill>
        <p:spPr>
          <a:xfrm>
            <a:off x="2560680" y="1214280"/>
            <a:ext cx="3517920" cy="343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文本框 6"/>
          <p:cNvSpPr/>
          <p:nvPr/>
        </p:nvSpPr>
        <p:spPr>
          <a:xfrm>
            <a:off x="566640" y="8788320"/>
            <a:ext cx="53024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ure 6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onfidence plot of the Alphafold 3 prediction binding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C.</a:t>
            </a:r>
            <a:r>
              <a:rPr b="0" i="1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sinense</a:t>
            </a:r>
            <a:r>
              <a:rPr b="0" i="1" lang="zh-CN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等线"/>
              </a:rPr>
              <a:t>promoter region. To the right and below the confidence plot, the corresponding proteins are labelled and regions of interest were red circle mark. (A) CsAP2_81 target CsFHS. (2) CsAP2_61 target CsPsaI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5"/>
          <p:cNvSpPr/>
          <p:nvPr/>
        </p:nvSpPr>
        <p:spPr>
          <a:xfrm>
            <a:off x="304200" y="439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" name="组合 12"/>
          <p:cNvGrpSpPr/>
          <p:nvPr/>
        </p:nvGrpSpPr>
        <p:grpSpPr>
          <a:xfrm>
            <a:off x="301680" y="5118120"/>
            <a:ext cx="6087960" cy="3384360"/>
            <a:chOff x="301680" y="5118120"/>
            <a:chExt cx="6087960" cy="3384360"/>
          </a:xfrm>
        </p:grpSpPr>
        <p:pic>
          <p:nvPicPr>
            <p:cNvPr id="70" name="图片 3" descr=""/>
            <p:cNvPicPr/>
            <p:nvPr/>
          </p:nvPicPr>
          <p:blipFill>
            <a:blip r:embed="rId1"/>
            <a:stretch/>
          </p:blipFill>
          <p:spPr>
            <a:xfrm>
              <a:off x="301680" y="5118120"/>
              <a:ext cx="6087960" cy="338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椭圆 9"/>
            <p:cNvSpPr/>
            <p:nvPr/>
          </p:nvSpPr>
          <p:spPr>
            <a:xfrm>
              <a:off x="2463840" y="6902280"/>
              <a:ext cx="658800" cy="660240"/>
            </a:xfrm>
            <a:prstGeom prst="ellipse">
              <a:avLst/>
            </a:prstGeom>
            <a:noFill/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文本框 10"/>
          <p:cNvSpPr/>
          <p:nvPr/>
        </p:nvSpPr>
        <p:spPr>
          <a:xfrm>
            <a:off x="310320" y="46944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图片 16" descr=""/>
          <p:cNvPicPr/>
          <p:nvPr/>
        </p:nvPicPr>
        <p:blipFill>
          <a:blip r:embed="rId2"/>
          <a:stretch/>
        </p:blipFill>
        <p:spPr>
          <a:xfrm>
            <a:off x="235080" y="863640"/>
            <a:ext cx="6154560" cy="3382920"/>
          </a:xfrm>
          <a:prstGeom prst="rect">
            <a:avLst/>
          </a:prstGeom>
          <a:ln w="0">
            <a:noFill/>
          </a:ln>
        </p:spPr>
      </p:pic>
      <p:sp>
        <p:nvSpPr>
          <p:cNvPr id="74" name="椭圆 17"/>
          <p:cNvSpPr/>
          <p:nvPr/>
        </p:nvSpPr>
        <p:spPr>
          <a:xfrm>
            <a:off x="2189160" y="2989440"/>
            <a:ext cx="660240" cy="658800"/>
          </a:xfrm>
          <a:prstGeom prst="ellipse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12-03T21:19:48Z</dcterms:created>
  <dc:creator>yonglu wei</dc:creator>
  <dc:description/>
  <dc:language>en-US</dc:language>
  <cp:lastModifiedBy>yonglu wei</cp:lastModifiedBy>
  <dcterms:modified xsi:type="dcterms:W3CDTF">2025-04-24T22:08:41Z</dcterms:modified>
  <cp:revision>14</cp:revision>
  <dc:subject/>
  <dc:title>PowerPoint 演示文稿</dc:title>
</cp:coreProperties>
</file>